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3" autoAdjust="0"/>
    <p:restoredTop sz="94660"/>
  </p:normalViewPr>
  <p:slideViewPr>
    <p:cSldViewPr snapToGrid="0">
      <p:cViewPr varScale="1">
        <p:scale>
          <a:sx n="64" d="100"/>
          <a:sy n="64" d="100"/>
        </p:scale>
        <p:origin x="86" y="1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3236218293264987E-2"/>
          <c:y val="0.17936208669373624"/>
          <c:w val="0.95487892263325203"/>
          <c:h val="0.701684309311216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4</c:f>
              <c:strCache>
                <c:ptCount val="1"/>
                <c:pt idx="0">
                  <c:v>2017 (N=494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3:$I$3</c:f>
              <c:strCache>
                <c:ptCount val="8"/>
                <c:pt idx="0">
                  <c:v>Social asset building</c:v>
                </c:pt>
                <c:pt idx="1">
                  <c:v>School-based HIV and violence prevention </c:v>
                </c:pt>
                <c:pt idx="2">
                  <c:v>Financial capability training</c:v>
                </c:pt>
                <c:pt idx="3">
                  <c:v>HIV testing and counselling</c:v>
                </c:pt>
                <c:pt idx="4">
                  <c:v>Post-violence care services</c:v>
                </c:pt>
                <c:pt idx="5">
                  <c:v>Educational subsidy</c:v>
                </c:pt>
                <c:pt idx="6">
                  <c:v> Parenting/caregiver programs</c:v>
                </c:pt>
                <c:pt idx="7">
                  <c:v> Community mobilisation &amp; norms change</c:v>
                </c:pt>
              </c:strCache>
            </c:strRef>
          </c:cat>
          <c:val>
            <c:numRef>
              <c:f>Sheet1!$B$4:$I$4</c:f>
              <c:numCache>
                <c:formatCode>0</c:formatCode>
                <c:ptCount val="8"/>
                <c:pt idx="0">
                  <c:v>36.4</c:v>
                </c:pt>
                <c:pt idx="1">
                  <c:v>41.9</c:v>
                </c:pt>
                <c:pt idx="2">
                  <c:v>8.9</c:v>
                </c:pt>
                <c:pt idx="3">
                  <c:v>55.5</c:v>
                </c:pt>
                <c:pt idx="4">
                  <c:v>24.9</c:v>
                </c:pt>
                <c:pt idx="5">
                  <c:v>21.1</c:v>
                </c:pt>
                <c:pt idx="6">
                  <c:v>4</c:v>
                </c:pt>
                <c:pt idx="7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BD3-455D-99ED-A714DDCC0F41}"/>
            </c:ext>
          </c:extLst>
        </c:ser>
        <c:ser>
          <c:idx val="1"/>
          <c:order val="1"/>
          <c:tx>
            <c:strRef>
              <c:f>Sheet1!$A$5</c:f>
              <c:strCache>
                <c:ptCount val="1"/>
                <c:pt idx="0">
                  <c:v>2018 (N*=457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3:$I$3</c:f>
              <c:strCache>
                <c:ptCount val="8"/>
                <c:pt idx="0">
                  <c:v>Social asset building</c:v>
                </c:pt>
                <c:pt idx="1">
                  <c:v>School-based HIV and violence prevention </c:v>
                </c:pt>
                <c:pt idx="2">
                  <c:v>Financial capability training</c:v>
                </c:pt>
                <c:pt idx="3">
                  <c:v>HIV testing and counselling</c:v>
                </c:pt>
                <c:pt idx="4">
                  <c:v>Post-violence care services</c:v>
                </c:pt>
                <c:pt idx="5">
                  <c:v>Educational subsidy</c:v>
                </c:pt>
                <c:pt idx="6">
                  <c:v> Parenting/caregiver programs</c:v>
                </c:pt>
                <c:pt idx="7">
                  <c:v> Community mobilisation &amp; norms change</c:v>
                </c:pt>
              </c:strCache>
            </c:strRef>
          </c:cat>
          <c:val>
            <c:numRef>
              <c:f>Sheet1!$B$5:$I$5</c:f>
              <c:numCache>
                <c:formatCode>0</c:formatCode>
                <c:ptCount val="8"/>
                <c:pt idx="0">
                  <c:v>48.1</c:v>
                </c:pt>
                <c:pt idx="1">
                  <c:v>56.7</c:v>
                </c:pt>
                <c:pt idx="2">
                  <c:v>34.1</c:v>
                </c:pt>
                <c:pt idx="3">
                  <c:v>59.5</c:v>
                </c:pt>
                <c:pt idx="4">
                  <c:v>26.7</c:v>
                </c:pt>
                <c:pt idx="5">
                  <c:v>29.1</c:v>
                </c:pt>
                <c:pt idx="6">
                  <c:v>9</c:v>
                </c:pt>
                <c:pt idx="7">
                  <c:v>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BD3-455D-99ED-A714DDCC0F41}"/>
            </c:ext>
          </c:extLst>
        </c:ser>
        <c:ser>
          <c:idx val="2"/>
          <c:order val="2"/>
          <c:tx>
            <c:strRef>
              <c:f>Sheet1!$A$6</c:f>
              <c:strCache>
                <c:ptCount val="1"/>
                <c:pt idx="0">
                  <c:v>2019 (N=494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3:$I$3</c:f>
              <c:strCache>
                <c:ptCount val="8"/>
                <c:pt idx="0">
                  <c:v>Social asset building</c:v>
                </c:pt>
                <c:pt idx="1">
                  <c:v>School-based HIV and violence prevention </c:v>
                </c:pt>
                <c:pt idx="2">
                  <c:v>Financial capability training</c:v>
                </c:pt>
                <c:pt idx="3">
                  <c:v>HIV testing and counselling</c:v>
                </c:pt>
                <c:pt idx="4">
                  <c:v>Post-violence care services</c:v>
                </c:pt>
                <c:pt idx="5">
                  <c:v>Educational subsidy</c:v>
                </c:pt>
                <c:pt idx="6">
                  <c:v> Parenting/caregiver programs</c:v>
                </c:pt>
                <c:pt idx="7">
                  <c:v> Community mobilisation &amp; norms change</c:v>
                </c:pt>
              </c:strCache>
            </c:strRef>
          </c:cat>
          <c:val>
            <c:numRef>
              <c:f>Sheet1!$B$6:$I$6</c:f>
              <c:numCache>
                <c:formatCode>0</c:formatCode>
                <c:ptCount val="8"/>
                <c:pt idx="0">
                  <c:v>36.6</c:v>
                </c:pt>
                <c:pt idx="1">
                  <c:v>55.1</c:v>
                </c:pt>
                <c:pt idx="2">
                  <c:v>28.3</c:v>
                </c:pt>
                <c:pt idx="3">
                  <c:v>55.1</c:v>
                </c:pt>
                <c:pt idx="4">
                  <c:v>4.7</c:v>
                </c:pt>
                <c:pt idx="5">
                  <c:v>32</c:v>
                </c:pt>
                <c:pt idx="6">
                  <c:v>11</c:v>
                </c:pt>
                <c:pt idx="7">
                  <c:v>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BD3-455D-99ED-A714DDCC0F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82916815"/>
        <c:axId val="782917647"/>
        <c:extLst/>
      </c:barChart>
      <c:catAx>
        <c:axId val="78291681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82917647"/>
        <c:crosses val="autoZero"/>
        <c:auto val="1"/>
        <c:lblAlgn val="ctr"/>
        <c:lblOffset val="100"/>
        <c:noMultiLvlLbl val="0"/>
      </c:catAx>
      <c:valAx>
        <c:axId val="782917647"/>
        <c:scaling>
          <c:orientation val="minMax"/>
          <c:max val="100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82916815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4697447464389322"/>
          <c:y val="5.1882426289808728E-2"/>
          <c:w val="0.18800818176736847"/>
          <c:h val="0.12888644957941675"/>
        </c:manualLayout>
      </c:layout>
      <c:overlay val="0"/>
      <c:spPr>
        <a:solidFill>
          <a:schemeClr val="bg1">
            <a:lumMod val="95000"/>
          </a:schemeClr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C80931-0E1F-44F1-8FDF-E682C1352F48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02F84A-8DB5-4BF1-BB62-52320E60B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295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1691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3038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558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826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0128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3026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1033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964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924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524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607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271497945"/>
              </p:ext>
            </p:extLst>
          </p:nvPr>
        </p:nvGraphicFramePr>
        <p:xfrm>
          <a:off x="276726" y="599090"/>
          <a:ext cx="11915274" cy="53129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0" y="1311442"/>
            <a:ext cx="430887" cy="287696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600" dirty="0"/>
              <a:t>% </a:t>
            </a:r>
            <a:r>
              <a:rPr lang="en-GB" sz="1600" dirty="0" smtClean="0"/>
              <a:t>accessing </a:t>
            </a:r>
            <a:r>
              <a:rPr lang="en-GB" sz="1600" dirty="0"/>
              <a:t>each </a:t>
            </a:r>
            <a:r>
              <a:rPr lang="en-GB" sz="1600" dirty="0" smtClean="0"/>
              <a:t>intervention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2762776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865</TotalTime>
  <Words>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Mulwa</dc:creator>
  <cp:lastModifiedBy>Sarah Mulwa</cp:lastModifiedBy>
  <cp:revision>200</cp:revision>
  <dcterms:created xsi:type="dcterms:W3CDTF">2019-09-20T09:43:17Z</dcterms:created>
  <dcterms:modified xsi:type="dcterms:W3CDTF">2021-03-14T11:13:34Z</dcterms:modified>
</cp:coreProperties>
</file>